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68" r:id="rId2"/>
    <p:sldId id="469" r:id="rId3"/>
    <p:sldId id="470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6" autoAdjust="0"/>
    <p:restoredTop sz="94660"/>
  </p:normalViewPr>
  <p:slideViewPr>
    <p:cSldViewPr snapToGrid="0">
      <p:cViewPr varScale="1">
        <p:scale>
          <a:sx n="90" d="100"/>
          <a:sy n="90" d="100"/>
        </p:scale>
        <p:origin x="132" y="6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B3607E-CE7E-47D9-8E4E-999CE2B3101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A205734A-2318-4215-9A91-0FACBCFC773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796C34-100D-4A9D-827C-615B055B1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F1B00B-DB73-4D75-8059-F66A23601B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7DDB0F-DA67-4A8D-8C83-8C03C7CD4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83100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D7A2266-1E9A-4D4A-B57C-9FDBAEDC511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099EB2C-7032-49DA-8E39-7F52023580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8A0200B-1B54-472B-872A-BC6DB46D2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C1BA65-3F66-4C3E-8405-1536E645AE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712F89-2753-4F0F-9198-FCFBC5646A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36054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89603DE8-0A79-445F-9AE3-0E04DB4A67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0D59FD3-B48C-44B2-ADD6-01A7EDEB85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B1E5642-A2E3-4D75-A158-8172F5B61AA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6F0E183-E580-4837-96EA-BC4BC6EEA4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EFE72B7-1145-4D8C-B645-E5DDFF2C4E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754541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D2C00DB-0632-4BE8-A779-5BAFF208D6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0F54C85-2B0F-4970-A25C-54E5566D8DE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C4E6AE4-C1AF-4F24-B591-563A144C7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F9909E-5D08-49D9-BE6B-CECC2C9A20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54E8F5-3FA6-4FEE-B8DC-33033BD20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97460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50B4F47-06B6-40DE-B173-8BB42F1834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14038C2-86A7-42D5-B39A-152CB187DF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4BB7473-D130-42CF-A80A-38F434EC5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BFB2AA1-B70C-4157-9F69-C17385F523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C4048C3-8D11-47EB-9386-5E9ADD34FD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55653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0ECE8AC-660C-48B0-B305-6ADC12519E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02B67EA-15CB-4F7F-8818-461E7ABAE41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AD590C0-1B8C-4774-A288-916B29C423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0C4CD0E-88C4-4C92-A402-CEB6E15803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11780D0-C01B-4E37-9FA5-1A3EADFAB0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A9201A5-BED9-4D88-9022-48AAC14445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33203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42EC7B3-EE83-4EF8-9CD3-3786AE3FAD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4F019981-E202-4848-B9CF-E935C5C415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1CFB42A9-1363-4632-8129-1A811EB94B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A232B7DF-6918-481F-ADAE-A98DF2FCD0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2B66B688-4017-4FC0-B368-338CDD3D6B8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65E444F-1044-4BC1-967E-59641367CD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DCEA02E7-885B-4105-9C63-40F1EB9DDE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A1934A9-3536-4DE0-962B-3D6E1FB31B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93620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F4803C-34E0-4AA2-9BEF-888C76DB92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AF15EF2A-272A-4FE5-ADC9-2DA3C6D508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40B88AB8-36A8-4922-97BD-5FBE400F8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AC6941F-FDB6-4CF0-8B12-F726302EBD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476476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804A25A-8DA4-4F1C-89EF-7131951781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5DB8A35-6479-4D7C-A040-DCEAB2D758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E8C9644C-B921-41FD-A818-892DE917A7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490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C04C68F-C8E5-47B1-A73C-5A87CFE786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F3DD6B0-DC20-472B-80E8-9F904A62AA7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1569E10-D07E-45F4-A9C5-274C9406F1A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431A518-01AE-4DCD-B23D-9BDD3C9A88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4C8E59B4-DB36-48CE-8EBB-9B8384798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A2A9125-B137-4B69-8C8A-A54986376E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0359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3E105AC-3871-456D-9B33-231A531A6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D7558D7A-6A2F-4BA2-8806-A780E03E028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35D1753C-D889-4895-B677-728A7DE4DC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2DA04AA-1658-42C3-8975-CA7FE7619C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498A24A-4195-4802-9669-F30D2EFBD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6B920E4-00AF-4C61-A21F-7737065489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860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27815FA-4A58-4D85-88A2-0286FB1CD6C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F5FC8BF-55B0-4B08-9871-DEFDC07CF9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C79C3A8-A64A-47E1-B734-501BE9CCCC8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079602-9D0A-4797-989F-6CB88373F52E}" type="datetimeFigureOut">
              <a:rPr lang="zh-CN" altLang="en-US" smtClean="0"/>
              <a:t>2024/10/3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6B5A55A-54C7-4DB0-9519-0AFD013307F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97F85A-1F55-41A3-9F5B-4F56553FFA3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50AEE3-B5EE-4336-A4D6-95E1AC5D37C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04974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图片 7">
            <a:extLst>
              <a:ext uri="{FF2B5EF4-FFF2-40B4-BE49-F238E27FC236}">
                <a16:creationId xmlns:a16="http://schemas.microsoft.com/office/drawing/2014/main" id="{0873C5EE-E3F3-475C-941F-786370AA66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6405" y="1531293"/>
            <a:ext cx="4690448" cy="1351333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98CD9EB6-6D95-4FDC-915A-385B2CC6566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2509" y="3239065"/>
            <a:ext cx="5060853" cy="1689312"/>
          </a:xfrm>
          <a:prstGeom prst="rect">
            <a:avLst/>
          </a:prstGeom>
        </p:spPr>
      </p:pic>
      <p:sp>
        <p:nvSpPr>
          <p:cNvPr id="13" name="矩形 12">
            <a:extLst>
              <a:ext uri="{FF2B5EF4-FFF2-40B4-BE49-F238E27FC236}">
                <a16:creationId xmlns:a16="http://schemas.microsoft.com/office/drawing/2014/main" id="{C7C6ECEA-BD76-4EA4-8D36-A5C5AD496F17}"/>
              </a:ext>
            </a:extLst>
          </p:cNvPr>
          <p:cNvSpPr/>
          <p:nvPr/>
        </p:nvSpPr>
        <p:spPr>
          <a:xfrm>
            <a:off x="1056000" y="1989000"/>
            <a:ext cx="3420000" cy="5400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FCB3898F-B318-4FC2-830F-40AD5E3948C2}"/>
              </a:ext>
            </a:extLst>
          </p:cNvPr>
          <p:cNvSpPr/>
          <p:nvPr/>
        </p:nvSpPr>
        <p:spPr>
          <a:xfrm>
            <a:off x="1056000" y="3609000"/>
            <a:ext cx="3600000" cy="7200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590FEA8-6A51-480C-9110-4CDDA694CF2A}"/>
              </a:ext>
            </a:extLst>
          </p:cNvPr>
          <p:cNvSpPr txBox="1"/>
          <p:nvPr/>
        </p:nvSpPr>
        <p:spPr>
          <a:xfrm>
            <a:off x="489064" y="1745044"/>
            <a:ext cx="4166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Ctrl       0.0001    0.001       0.01         0.1          1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99167146-F4FE-4A8F-9269-F1B708CE4A8B}"/>
              </a:ext>
            </a:extLst>
          </p:cNvPr>
          <p:cNvSpPr txBox="1"/>
          <p:nvPr/>
        </p:nvSpPr>
        <p:spPr>
          <a:xfrm>
            <a:off x="429890" y="2146988"/>
            <a:ext cx="626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C6602F4F-1E70-4939-B5FC-8E57F57F71F7}"/>
              </a:ext>
            </a:extLst>
          </p:cNvPr>
          <p:cNvSpPr txBox="1"/>
          <p:nvPr/>
        </p:nvSpPr>
        <p:spPr>
          <a:xfrm>
            <a:off x="2240986" y="1395503"/>
            <a:ext cx="1230028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K506 (</a:t>
            </a:r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1FC2871D-DB66-4255-8BB7-576AFFE73B88}"/>
              </a:ext>
            </a:extLst>
          </p:cNvPr>
          <p:cNvCxnSpPr>
            <a:cxnSpLocks/>
          </p:cNvCxnSpPr>
          <p:nvPr/>
        </p:nvCxnSpPr>
        <p:spPr>
          <a:xfrm>
            <a:off x="1236000" y="1691128"/>
            <a:ext cx="3060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文本框 19">
            <a:extLst>
              <a:ext uri="{FF2B5EF4-FFF2-40B4-BE49-F238E27FC236}">
                <a16:creationId xmlns:a16="http://schemas.microsoft.com/office/drawing/2014/main" id="{310DE658-BE10-4A02-A77B-89C43B30EA24}"/>
              </a:ext>
            </a:extLst>
          </p:cNvPr>
          <p:cNvSpPr txBox="1"/>
          <p:nvPr/>
        </p:nvSpPr>
        <p:spPr>
          <a:xfrm>
            <a:off x="516000" y="3354705"/>
            <a:ext cx="416693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Ctrl       0.0001    0.001       0.01         0.1          1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E5F10C12-F67B-4A85-8A18-6606B7C02460}"/>
              </a:ext>
            </a:extLst>
          </p:cNvPr>
          <p:cNvSpPr txBox="1"/>
          <p:nvPr/>
        </p:nvSpPr>
        <p:spPr>
          <a:xfrm>
            <a:off x="2267922" y="3005164"/>
            <a:ext cx="1230028" cy="277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K506 (</a:t>
            </a:r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接连接符 21">
            <a:extLst>
              <a:ext uri="{FF2B5EF4-FFF2-40B4-BE49-F238E27FC236}">
                <a16:creationId xmlns:a16="http://schemas.microsoft.com/office/drawing/2014/main" id="{C97B9A31-2CBA-4027-BFE9-D6126E98E823}"/>
              </a:ext>
            </a:extLst>
          </p:cNvPr>
          <p:cNvCxnSpPr>
            <a:cxnSpLocks/>
          </p:cNvCxnSpPr>
          <p:nvPr/>
        </p:nvCxnSpPr>
        <p:spPr>
          <a:xfrm>
            <a:off x="1262936" y="3300789"/>
            <a:ext cx="3060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3" name="文本框 22">
            <a:extLst>
              <a:ext uri="{FF2B5EF4-FFF2-40B4-BE49-F238E27FC236}">
                <a16:creationId xmlns:a16="http://schemas.microsoft.com/office/drawing/2014/main" id="{BCB21595-6E25-4CC7-8C36-ADCD1CFB09A3}"/>
              </a:ext>
            </a:extLst>
          </p:cNvPr>
          <p:cNvSpPr txBox="1"/>
          <p:nvPr/>
        </p:nvSpPr>
        <p:spPr>
          <a:xfrm>
            <a:off x="254255" y="3841852"/>
            <a:ext cx="90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tubuli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F4D97D0-C228-4CBC-A2F0-3597D40F2325}"/>
              </a:ext>
            </a:extLst>
          </p:cNvPr>
          <p:cNvSpPr txBox="1"/>
          <p:nvPr/>
        </p:nvSpPr>
        <p:spPr>
          <a:xfrm>
            <a:off x="254255" y="736431"/>
            <a:ext cx="11617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2E</a:t>
            </a:r>
            <a:endParaRPr lang="zh-CN" altLang="en-US" dirty="0"/>
          </a:p>
        </p:txBody>
      </p:sp>
      <p:pic>
        <p:nvPicPr>
          <p:cNvPr id="29" name="图片 28">
            <a:extLst>
              <a:ext uri="{FF2B5EF4-FFF2-40B4-BE49-F238E27FC236}">
                <a16:creationId xmlns:a16="http://schemas.microsoft.com/office/drawing/2014/main" id="{B7804476-0A3C-403F-A593-638A8B4B74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29595" y="1672503"/>
            <a:ext cx="4956000" cy="1541791"/>
          </a:xfrm>
          <a:prstGeom prst="rect">
            <a:avLst/>
          </a:prstGeom>
        </p:spPr>
      </p:pic>
      <p:pic>
        <p:nvPicPr>
          <p:cNvPr id="33" name="图片 32">
            <a:extLst>
              <a:ext uri="{FF2B5EF4-FFF2-40B4-BE49-F238E27FC236}">
                <a16:creationId xmlns:a16="http://schemas.microsoft.com/office/drawing/2014/main" id="{92844AC9-0BDE-4420-BF25-30C7257E5B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88739" y="3248045"/>
            <a:ext cx="4630492" cy="1393711"/>
          </a:xfrm>
          <a:prstGeom prst="rect">
            <a:avLst/>
          </a:prstGeom>
        </p:spPr>
      </p:pic>
      <p:sp>
        <p:nvSpPr>
          <p:cNvPr id="34" name="矩形 33">
            <a:extLst>
              <a:ext uri="{FF2B5EF4-FFF2-40B4-BE49-F238E27FC236}">
                <a16:creationId xmlns:a16="http://schemas.microsoft.com/office/drawing/2014/main" id="{DA7F2EAE-4CF5-43EA-AFF9-AC26D0F62FCE}"/>
              </a:ext>
            </a:extLst>
          </p:cNvPr>
          <p:cNvSpPr/>
          <p:nvPr/>
        </p:nvSpPr>
        <p:spPr>
          <a:xfrm>
            <a:off x="7129543" y="2243953"/>
            <a:ext cx="3420000" cy="5400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35" name="矩形 34">
            <a:extLst>
              <a:ext uri="{FF2B5EF4-FFF2-40B4-BE49-F238E27FC236}">
                <a16:creationId xmlns:a16="http://schemas.microsoft.com/office/drawing/2014/main" id="{6626203E-67C3-47EC-A6BC-CF5BCB068B75}"/>
              </a:ext>
            </a:extLst>
          </p:cNvPr>
          <p:cNvSpPr/>
          <p:nvPr/>
        </p:nvSpPr>
        <p:spPr>
          <a:xfrm>
            <a:off x="7129543" y="3609291"/>
            <a:ext cx="3420000" cy="5400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93FCAA0C-E3E1-420F-83E0-900A1BC977D6}"/>
              </a:ext>
            </a:extLst>
          </p:cNvPr>
          <p:cNvSpPr txBox="1"/>
          <p:nvPr/>
        </p:nvSpPr>
        <p:spPr>
          <a:xfrm>
            <a:off x="6121350" y="736431"/>
            <a:ext cx="11617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2F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5E734E9C-369C-4387-9E49-72E84F4E7792}"/>
              </a:ext>
            </a:extLst>
          </p:cNvPr>
          <p:cNvSpPr txBox="1"/>
          <p:nvPr/>
        </p:nvSpPr>
        <p:spPr>
          <a:xfrm>
            <a:off x="6389167" y="2416102"/>
            <a:ext cx="626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24B025BA-8E90-44CB-BF3E-14812DD526B5}"/>
              </a:ext>
            </a:extLst>
          </p:cNvPr>
          <p:cNvSpPr txBox="1"/>
          <p:nvPr/>
        </p:nvSpPr>
        <p:spPr>
          <a:xfrm>
            <a:off x="6383095" y="3740791"/>
            <a:ext cx="90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9" name="直接连接符 38">
            <a:extLst>
              <a:ext uri="{FF2B5EF4-FFF2-40B4-BE49-F238E27FC236}">
                <a16:creationId xmlns:a16="http://schemas.microsoft.com/office/drawing/2014/main" id="{88B3CA36-38B2-424B-9A16-0DE13213A3E2}"/>
              </a:ext>
            </a:extLst>
          </p:cNvPr>
          <p:cNvCxnSpPr>
            <a:cxnSpLocks/>
          </p:cNvCxnSpPr>
          <p:nvPr/>
        </p:nvCxnSpPr>
        <p:spPr>
          <a:xfrm flipH="1">
            <a:off x="7356000" y="2055454"/>
            <a:ext cx="121281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直接连接符 39">
            <a:extLst>
              <a:ext uri="{FF2B5EF4-FFF2-40B4-BE49-F238E27FC236}">
                <a16:creationId xmlns:a16="http://schemas.microsoft.com/office/drawing/2014/main" id="{64A90613-EA98-40E8-8934-FEE225EA1CAD}"/>
              </a:ext>
            </a:extLst>
          </p:cNvPr>
          <p:cNvCxnSpPr>
            <a:cxnSpLocks/>
          </p:cNvCxnSpPr>
          <p:nvPr/>
        </p:nvCxnSpPr>
        <p:spPr>
          <a:xfrm flipH="1">
            <a:off x="8976001" y="2037377"/>
            <a:ext cx="12599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文本框 40">
            <a:extLst>
              <a:ext uri="{FF2B5EF4-FFF2-40B4-BE49-F238E27FC236}">
                <a16:creationId xmlns:a16="http://schemas.microsoft.com/office/drawing/2014/main" id="{4051B0CB-F942-48F7-A57B-33F1ADE1E136}"/>
              </a:ext>
            </a:extLst>
          </p:cNvPr>
          <p:cNvSpPr txBox="1"/>
          <p:nvPr/>
        </p:nvSpPr>
        <p:spPr>
          <a:xfrm>
            <a:off x="7772345" y="1761406"/>
            <a:ext cx="538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P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729E037-EF78-4118-8373-58E1BD7C3B94}"/>
              </a:ext>
            </a:extLst>
          </p:cNvPr>
          <p:cNvSpPr txBox="1"/>
          <p:nvPr/>
        </p:nvSpPr>
        <p:spPr>
          <a:xfrm>
            <a:off x="9421801" y="1743502"/>
            <a:ext cx="690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PL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5" name="直接连接符 44">
            <a:extLst>
              <a:ext uri="{FF2B5EF4-FFF2-40B4-BE49-F238E27FC236}">
                <a16:creationId xmlns:a16="http://schemas.microsoft.com/office/drawing/2014/main" id="{B273393F-9479-4CDE-9F3D-12F8AAB73247}"/>
              </a:ext>
            </a:extLst>
          </p:cNvPr>
          <p:cNvCxnSpPr>
            <a:cxnSpLocks/>
          </p:cNvCxnSpPr>
          <p:nvPr/>
        </p:nvCxnSpPr>
        <p:spPr>
          <a:xfrm flipH="1">
            <a:off x="7356000" y="3489660"/>
            <a:ext cx="1212817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6" name="直接连接符 45">
            <a:extLst>
              <a:ext uri="{FF2B5EF4-FFF2-40B4-BE49-F238E27FC236}">
                <a16:creationId xmlns:a16="http://schemas.microsoft.com/office/drawing/2014/main" id="{4B0370FE-31E3-4DAE-A260-D31100B9D6FF}"/>
              </a:ext>
            </a:extLst>
          </p:cNvPr>
          <p:cNvCxnSpPr>
            <a:cxnSpLocks/>
          </p:cNvCxnSpPr>
          <p:nvPr/>
        </p:nvCxnSpPr>
        <p:spPr>
          <a:xfrm flipH="1">
            <a:off x="8976000" y="3472611"/>
            <a:ext cx="12599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" name="文本框 46">
            <a:extLst>
              <a:ext uri="{FF2B5EF4-FFF2-40B4-BE49-F238E27FC236}">
                <a16:creationId xmlns:a16="http://schemas.microsoft.com/office/drawing/2014/main" id="{9404A4D6-1498-4D40-B61A-005B773C602E}"/>
              </a:ext>
            </a:extLst>
          </p:cNvPr>
          <p:cNvSpPr txBox="1"/>
          <p:nvPr/>
        </p:nvSpPr>
        <p:spPr>
          <a:xfrm>
            <a:off x="7772345" y="3195612"/>
            <a:ext cx="538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P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4AB271E0-E301-44CA-AC5B-A68EFC57D6AB}"/>
              </a:ext>
            </a:extLst>
          </p:cNvPr>
          <p:cNvSpPr txBox="1"/>
          <p:nvPr/>
        </p:nvSpPr>
        <p:spPr>
          <a:xfrm>
            <a:off x="9421801" y="3177708"/>
            <a:ext cx="690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PL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21DB6BE6-D6E4-47F0-81A7-4611EB4F0FE0}"/>
              </a:ext>
            </a:extLst>
          </p:cNvPr>
          <p:cNvSpPr txBox="1"/>
          <p:nvPr/>
        </p:nvSpPr>
        <p:spPr>
          <a:xfrm>
            <a:off x="4926246" y="2416102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80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459F31E4-D5F9-4115-82C8-D41F67D8A7F8}"/>
              </a:ext>
            </a:extLst>
          </p:cNvPr>
          <p:cNvSpPr txBox="1"/>
          <p:nvPr/>
        </p:nvSpPr>
        <p:spPr>
          <a:xfrm>
            <a:off x="4476000" y="2183232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273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A6F35C4-0D5C-42B3-A59B-E7C23E4FD0A9}"/>
              </a:ext>
            </a:extLst>
          </p:cNvPr>
          <p:cNvSpPr txBox="1"/>
          <p:nvPr/>
        </p:nvSpPr>
        <p:spPr>
          <a:xfrm>
            <a:off x="10802970" y="2555075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80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0793230B-7F12-4B98-9C72-42F02871B734}"/>
              </a:ext>
            </a:extLst>
          </p:cNvPr>
          <p:cNvSpPr txBox="1"/>
          <p:nvPr/>
        </p:nvSpPr>
        <p:spPr>
          <a:xfrm>
            <a:off x="10472468" y="2407830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273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28F2592A-8AE0-4905-949A-326E790B1F53}"/>
              </a:ext>
            </a:extLst>
          </p:cNvPr>
          <p:cNvSpPr txBox="1"/>
          <p:nvPr/>
        </p:nvSpPr>
        <p:spPr>
          <a:xfrm>
            <a:off x="4656000" y="3849643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55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0CCACCE6-22BA-4C27-97B8-CD390B20A12B}"/>
              </a:ext>
            </a:extLst>
          </p:cNvPr>
          <p:cNvSpPr txBox="1"/>
          <p:nvPr/>
        </p:nvSpPr>
        <p:spPr>
          <a:xfrm>
            <a:off x="10725899" y="3740791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42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640570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8E692FFA-CAA9-48F9-937A-1F186C4DA469}"/>
              </a:ext>
            </a:extLst>
          </p:cNvPr>
          <p:cNvSpPr txBox="1"/>
          <p:nvPr/>
        </p:nvSpPr>
        <p:spPr>
          <a:xfrm>
            <a:off x="254255" y="736431"/>
            <a:ext cx="11617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4B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91FA8FD6-D07F-421E-853F-9145CFA0EC43}"/>
              </a:ext>
            </a:extLst>
          </p:cNvPr>
          <p:cNvSpPr txBox="1"/>
          <p:nvPr/>
        </p:nvSpPr>
        <p:spPr>
          <a:xfrm>
            <a:off x="6121350" y="736431"/>
            <a:ext cx="11617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4C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71AD1CA7-472E-484C-872F-9621A19298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54255" y="2151654"/>
            <a:ext cx="5040000" cy="1344818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F109F1BA-6235-452B-95BE-B9ABBBE7D90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5189" y="4285325"/>
            <a:ext cx="4140000" cy="1095443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CF824F01-AE9E-49F5-AD1A-935A541CC88F}"/>
              </a:ext>
            </a:extLst>
          </p:cNvPr>
          <p:cNvSpPr/>
          <p:nvPr/>
        </p:nvSpPr>
        <p:spPr>
          <a:xfrm>
            <a:off x="1056000" y="2841409"/>
            <a:ext cx="3338378" cy="49240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CE3CAE6B-490B-4371-8469-BDB4DD7F32C8}"/>
              </a:ext>
            </a:extLst>
          </p:cNvPr>
          <p:cNvSpPr/>
          <p:nvPr/>
        </p:nvSpPr>
        <p:spPr>
          <a:xfrm>
            <a:off x="1061829" y="4660055"/>
            <a:ext cx="3338378" cy="49240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B703823-A3DC-49AE-9DA8-89CEE7824336}"/>
              </a:ext>
            </a:extLst>
          </p:cNvPr>
          <p:cNvSpPr txBox="1"/>
          <p:nvPr/>
        </p:nvSpPr>
        <p:spPr>
          <a:xfrm>
            <a:off x="516000" y="2030500"/>
            <a:ext cx="37360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Ctrl    0.0001   0.001    0.01       0.1         1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0C19D6B-3213-4F41-992C-CEA125A4B89E}"/>
              </a:ext>
            </a:extLst>
          </p:cNvPr>
          <p:cNvSpPr txBox="1"/>
          <p:nvPr/>
        </p:nvSpPr>
        <p:spPr>
          <a:xfrm>
            <a:off x="2136000" y="1729607"/>
            <a:ext cx="1101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K506 (</a:t>
            </a:r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接连接符 18">
            <a:extLst>
              <a:ext uri="{FF2B5EF4-FFF2-40B4-BE49-F238E27FC236}">
                <a16:creationId xmlns:a16="http://schemas.microsoft.com/office/drawing/2014/main" id="{CF816BE9-6631-4F1A-BA8D-496691F59C4E}"/>
              </a:ext>
            </a:extLst>
          </p:cNvPr>
          <p:cNvCxnSpPr>
            <a:cxnSpLocks/>
          </p:cNvCxnSpPr>
          <p:nvPr/>
        </p:nvCxnSpPr>
        <p:spPr>
          <a:xfrm>
            <a:off x="1236000" y="2030500"/>
            <a:ext cx="2700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>
            <a:extLst>
              <a:ext uri="{FF2B5EF4-FFF2-40B4-BE49-F238E27FC236}">
                <a16:creationId xmlns:a16="http://schemas.microsoft.com/office/drawing/2014/main" id="{5DA7376E-19B0-4421-A5EA-FF3328CBA10B}"/>
              </a:ext>
            </a:extLst>
          </p:cNvPr>
          <p:cNvSpPr txBox="1"/>
          <p:nvPr/>
        </p:nvSpPr>
        <p:spPr>
          <a:xfrm>
            <a:off x="74255" y="2918320"/>
            <a:ext cx="998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ACAM1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563DFBB-6CF3-448C-A50F-E2F4C7AE49CF}"/>
              </a:ext>
            </a:extLst>
          </p:cNvPr>
          <p:cNvSpPr txBox="1"/>
          <p:nvPr/>
        </p:nvSpPr>
        <p:spPr>
          <a:xfrm>
            <a:off x="516695" y="4335826"/>
            <a:ext cx="37360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                 Ctrl    0.0001    0.001    0.01       0.1          1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C656538-7E9B-41E1-B7FF-B00A6436AA0F}"/>
              </a:ext>
            </a:extLst>
          </p:cNvPr>
          <p:cNvSpPr txBox="1"/>
          <p:nvPr/>
        </p:nvSpPr>
        <p:spPr>
          <a:xfrm>
            <a:off x="2136695" y="4034933"/>
            <a:ext cx="110172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K506 (</a:t>
            </a:r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μM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8" name="直接连接符 27">
            <a:extLst>
              <a:ext uri="{FF2B5EF4-FFF2-40B4-BE49-F238E27FC236}">
                <a16:creationId xmlns:a16="http://schemas.microsoft.com/office/drawing/2014/main" id="{FE519334-B96E-490C-8106-5ED27B2B715B}"/>
              </a:ext>
            </a:extLst>
          </p:cNvPr>
          <p:cNvCxnSpPr>
            <a:cxnSpLocks/>
          </p:cNvCxnSpPr>
          <p:nvPr/>
        </p:nvCxnSpPr>
        <p:spPr>
          <a:xfrm>
            <a:off x="1236695" y="4335826"/>
            <a:ext cx="2700000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0" name="文本框 29">
            <a:extLst>
              <a:ext uri="{FF2B5EF4-FFF2-40B4-BE49-F238E27FC236}">
                <a16:creationId xmlns:a16="http://schemas.microsoft.com/office/drawing/2014/main" id="{B3484FA8-5E39-4B79-871E-9497FFB73127}"/>
              </a:ext>
            </a:extLst>
          </p:cNvPr>
          <p:cNvSpPr txBox="1"/>
          <p:nvPr/>
        </p:nvSpPr>
        <p:spPr>
          <a:xfrm>
            <a:off x="275628" y="4762058"/>
            <a:ext cx="90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tubuli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E0BECCD7-1780-453C-9C52-EB2FA03E4C8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276000" y="2168999"/>
            <a:ext cx="5261499" cy="1258445"/>
          </a:xfrm>
          <a:prstGeom prst="rect">
            <a:avLst/>
          </a:prstGeom>
        </p:spPr>
      </p:pic>
      <p:pic>
        <p:nvPicPr>
          <p:cNvPr id="38" name="图片 37">
            <a:extLst>
              <a:ext uri="{FF2B5EF4-FFF2-40B4-BE49-F238E27FC236}">
                <a16:creationId xmlns:a16="http://schemas.microsoft.com/office/drawing/2014/main" id="{E7B37FCE-4DF7-48CC-9335-3E77CEBBD84E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57711" y="4009072"/>
            <a:ext cx="5191748" cy="1505972"/>
          </a:xfrm>
          <a:prstGeom prst="rect">
            <a:avLst/>
          </a:prstGeom>
        </p:spPr>
      </p:pic>
      <p:sp>
        <p:nvSpPr>
          <p:cNvPr id="39" name="矩形 38">
            <a:extLst>
              <a:ext uri="{FF2B5EF4-FFF2-40B4-BE49-F238E27FC236}">
                <a16:creationId xmlns:a16="http://schemas.microsoft.com/office/drawing/2014/main" id="{1940C76E-105C-4EB1-A855-42A0B5A754D4}"/>
              </a:ext>
            </a:extLst>
          </p:cNvPr>
          <p:cNvSpPr/>
          <p:nvPr/>
        </p:nvSpPr>
        <p:spPr>
          <a:xfrm>
            <a:off x="6707399" y="2349000"/>
            <a:ext cx="3960000" cy="73861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9D56936A-28F5-4A6C-B7A9-A494D542AEF8}"/>
              </a:ext>
            </a:extLst>
          </p:cNvPr>
          <p:cNvSpPr/>
          <p:nvPr/>
        </p:nvSpPr>
        <p:spPr>
          <a:xfrm>
            <a:off x="6773357" y="4313785"/>
            <a:ext cx="4140000" cy="738613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cxnSp>
        <p:nvCxnSpPr>
          <p:cNvPr id="41" name="直接连接符 40">
            <a:extLst>
              <a:ext uri="{FF2B5EF4-FFF2-40B4-BE49-F238E27FC236}">
                <a16:creationId xmlns:a16="http://schemas.microsoft.com/office/drawing/2014/main" id="{DCDCB9AE-0977-4AA0-98CA-024D9AA6688B}"/>
              </a:ext>
            </a:extLst>
          </p:cNvPr>
          <p:cNvCxnSpPr>
            <a:cxnSpLocks/>
          </p:cNvCxnSpPr>
          <p:nvPr/>
        </p:nvCxnSpPr>
        <p:spPr>
          <a:xfrm flipH="1">
            <a:off x="6996001" y="2168999"/>
            <a:ext cx="16199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2" name="直接连接符 41">
            <a:extLst>
              <a:ext uri="{FF2B5EF4-FFF2-40B4-BE49-F238E27FC236}">
                <a16:creationId xmlns:a16="http://schemas.microsoft.com/office/drawing/2014/main" id="{AEA93C3F-04C9-4DB9-A059-9A5A3B714964}"/>
              </a:ext>
            </a:extLst>
          </p:cNvPr>
          <p:cNvCxnSpPr>
            <a:cxnSpLocks/>
          </p:cNvCxnSpPr>
          <p:nvPr/>
        </p:nvCxnSpPr>
        <p:spPr>
          <a:xfrm flipH="1">
            <a:off x="8976000" y="2190471"/>
            <a:ext cx="161999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245F7CA2-1FEE-4F3D-A5FF-165E2D0C5493}"/>
              </a:ext>
            </a:extLst>
          </p:cNvPr>
          <p:cNvSpPr txBox="1"/>
          <p:nvPr/>
        </p:nvSpPr>
        <p:spPr>
          <a:xfrm>
            <a:off x="7592345" y="1896423"/>
            <a:ext cx="538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P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82DE87C-F822-4CAE-B4F3-212556D20F78}"/>
              </a:ext>
            </a:extLst>
          </p:cNvPr>
          <p:cNvSpPr txBox="1"/>
          <p:nvPr/>
        </p:nvSpPr>
        <p:spPr>
          <a:xfrm>
            <a:off x="9516000" y="1921183"/>
            <a:ext cx="690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PL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48" name="直接连接符 47">
            <a:extLst>
              <a:ext uri="{FF2B5EF4-FFF2-40B4-BE49-F238E27FC236}">
                <a16:creationId xmlns:a16="http://schemas.microsoft.com/office/drawing/2014/main" id="{556B56CB-4354-43DD-A8C5-B90EBDC14274}"/>
              </a:ext>
            </a:extLst>
          </p:cNvPr>
          <p:cNvCxnSpPr>
            <a:cxnSpLocks/>
          </p:cNvCxnSpPr>
          <p:nvPr/>
        </p:nvCxnSpPr>
        <p:spPr>
          <a:xfrm flipH="1">
            <a:off x="7176001" y="4098955"/>
            <a:ext cx="161999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直接连接符 48">
            <a:extLst>
              <a:ext uri="{FF2B5EF4-FFF2-40B4-BE49-F238E27FC236}">
                <a16:creationId xmlns:a16="http://schemas.microsoft.com/office/drawing/2014/main" id="{FF2E110B-32F7-4595-98B5-460460778588}"/>
              </a:ext>
            </a:extLst>
          </p:cNvPr>
          <p:cNvCxnSpPr>
            <a:cxnSpLocks/>
          </p:cNvCxnSpPr>
          <p:nvPr/>
        </p:nvCxnSpPr>
        <p:spPr>
          <a:xfrm flipH="1">
            <a:off x="9156000" y="4120427"/>
            <a:ext cx="1619998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0" name="文本框 49">
            <a:extLst>
              <a:ext uri="{FF2B5EF4-FFF2-40B4-BE49-F238E27FC236}">
                <a16:creationId xmlns:a16="http://schemas.microsoft.com/office/drawing/2014/main" id="{A1627EDE-4C92-4623-8B8D-AE6FF0619FEF}"/>
              </a:ext>
            </a:extLst>
          </p:cNvPr>
          <p:cNvSpPr txBox="1"/>
          <p:nvPr/>
        </p:nvSpPr>
        <p:spPr>
          <a:xfrm>
            <a:off x="7772345" y="3826379"/>
            <a:ext cx="5380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P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70C9A7B4-365C-4EA7-AA7A-55FDB56F1E41}"/>
              </a:ext>
            </a:extLst>
          </p:cNvPr>
          <p:cNvSpPr txBox="1"/>
          <p:nvPr/>
        </p:nvSpPr>
        <p:spPr>
          <a:xfrm>
            <a:off x="9696000" y="3851139"/>
            <a:ext cx="6908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PL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CD7E257-700F-4986-91CC-0E2462B4258D}"/>
              </a:ext>
            </a:extLst>
          </p:cNvPr>
          <p:cNvSpPr txBox="1"/>
          <p:nvPr/>
        </p:nvSpPr>
        <p:spPr>
          <a:xfrm>
            <a:off x="5775253" y="2636516"/>
            <a:ext cx="998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ACAM1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CA63E5F5-ACDB-4720-99ED-D02B149B4981}"/>
              </a:ext>
            </a:extLst>
          </p:cNvPr>
          <p:cNvSpPr txBox="1"/>
          <p:nvPr/>
        </p:nvSpPr>
        <p:spPr>
          <a:xfrm>
            <a:off x="6096000" y="4570777"/>
            <a:ext cx="90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BD982DE7-28B7-4720-AC65-D6370805B28B}"/>
              </a:ext>
            </a:extLst>
          </p:cNvPr>
          <p:cNvSpPr txBox="1"/>
          <p:nvPr/>
        </p:nvSpPr>
        <p:spPr>
          <a:xfrm>
            <a:off x="4554824" y="2349000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80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F3D92D33-2D2E-42BD-98AA-C8ED5A674290}"/>
              </a:ext>
            </a:extLst>
          </p:cNvPr>
          <p:cNvSpPr txBox="1"/>
          <p:nvPr/>
        </p:nvSpPr>
        <p:spPr>
          <a:xfrm>
            <a:off x="4554824" y="2559011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30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E1FC0A4-1A81-419B-A86F-BC69A187E58E}"/>
              </a:ext>
            </a:extLst>
          </p:cNvPr>
          <p:cNvSpPr txBox="1"/>
          <p:nvPr/>
        </p:nvSpPr>
        <p:spPr>
          <a:xfrm>
            <a:off x="4572917" y="3183130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95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4CA66E56-427F-4CAD-87F4-99B57F9F2D09}"/>
              </a:ext>
            </a:extLst>
          </p:cNvPr>
          <p:cNvSpPr txBox="1"/>
          <p:nvPr/>
        </p:nvSpPr>
        <p:spPr>
          <a:xfrm>
            <a:off x="4398526" y="2954826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10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F0968775-36F2-46C2-AC8D-DF27605DA977}"/>
              </a:ext>
            </a:extLst>
          </p:cNvPr>
          <p:cNvSpPr txBox="1"/>
          <p:nvPr/>
        </p:nvSpPr>
        <p:spPr>
          <a:xfrm>
            <a:off x="10709384" y="2579806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10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99E41C8C-6FF7-458D-B8E3-AC7ED9CCB3C8}"/>
              </a:ext>
            </a:extLst>
          </p:cNvPr>
          <p:cNvSpPr txBox="1"/>
          <p:nvPr/>
        </p:nvSpPr>
        <p:spPr>
          <a:xfrm>
            <a:off x="4405752" y="4853823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55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A15D07F-753F-479F-83D0-03015F1345CE}"/>
              </a:ext>
            </a:extLst>
          </p:cNvPr>
          <p:cNvSpPr txBox="1"/>
          <p:nvPr/>
        </p:nvSpPr>
        <p:spPr>
          <a:xfrm>
            <a:off x="10913357" y="4592590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42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821752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AD4BEB8E-0AD1-41D6-A459-D3BC02A8BFA6}"/>
              </a:ext>
            </a:extLst>
          </p:cNvPr>
          <p:cNvSpPr txBox="1"/>
          <p:nvPr/>
        </p:nvSpPr>
        <p:spPr>
          <a:xfrm>
            <a:off x="876000" y="714272"/>
            <a:ext cx="11617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SA</a:t>
            </a:r>
            <a:endParaRPr lang="zh-CN" altLang="en-US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7B4A36AF-47A3-4973-84E7-32B5DB9BE410}"/>
              </a:ext>
            </a:extLst>
          </p:cNvPr>
          <p:cNvSpPr txBox="1"/>
          <p:nvPr/>
        </p:nvSpPr>
        <p:spPr>
          <a:xfrm>
            <a:off x="7675141" y="729000"/>
            <a:ext cx="1161745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dirty="0"/>
              <a:t>Figure SB</a:t>
            </a:r>
            <a:endParaRPr lang="zh-CN" altLang="en-US" dirty="0"/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6F6AF039-D465-481E-B3C0-5BE921C672C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6000" y="1487354"/>
            <a:ext cx="5040000" cy="948256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DEA6FD75-E329-4F6A-AA5A-2A3E8C416E3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16000" y="2682294"/>
            <a:ext cx="1445981" cy="2121727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FA92D123-1F5E-462E-82B4-5A20DC1F20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55785" y="5093337"/>
            <a:ext cx="4860000" cy="1065344"/>
          </a:xfrm>
          <a:prstGeom prst="rect">
            <a:avLst/>
          </a:prstGeom>
        </p:spPr>
      </p:pic>
      <p:sp>
        <p:nvSpPr>
          <p:cNvPr id="18" name="矩形 17">
            <a:extLst>
              <a:ext uri="{FF2B5EF4-FFF2-40B4-BE49-F238E27FC236}">
                <a16:creationId xmlns:a16="http://schemas.microsoft.com/office/drawing/2014/main" id="{86FDA4F7-D2BB-41A5-98E2-16349C178A2C}"/>
              </a:ext>
            </a:extLst>
          </p:cNvPr>
          <p:cNvSpPr/>
          <p:nvPr/>
        </p:nvSpPr>
        <p:spPr>
          <a:xfrm>
            <a:off x="2654678" y="1776816"/>
            <a:ext cx="942643" cy="3693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19" name="矩形 18">
            <a:extLst>
              <a:ext uri="{FF2B5EF4-FFF2-40B4-BE49-F238E27FC236}">
                <a16:creationId xmlns:a16="http://schemas.microsoft.com/office/drawing/2014/main" id="{21A177AB-D492-43B0-B7F1-8B1D9C1444F2}"/>
              </a:ext>
            </a:extLst>
          </p:cNvPr>
          <p:cNvSpPr/>
          <p:nvPr/>
        </p:nvSpPr>
        <p:spPr>
          <a:xfrm>
            <a:off x="2676000" y="5339859"/>
            <a:ext cx="942643" cy="3693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20" name="矩形 19">
            <a:extLst>
              <a:ext uri="{FF2B5EF4-FFF2-40B4-BE49-F238E27FC236}">
                <a16:creationId xmlns:a16="http://schemas.microsoft.com/office/drawing/2014/main" id="{440089B4-3C7A-46E1-8F8A-8AFC21BEBF5D}"/>
              </a:ext>
            </a:extLst>
          </p:cNvPr>
          <p:cNvSpPr/>
          <p:nvPr/>
        </p:nvSpPr>
        <p:spPr>
          <a:xfrm>
            <a:off x="2584021" y="4149000"/>
            <a:ext cx="1080000" cy="54000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EF3C0ED-F94D-4CEB-A5E7-98C17A85AA8D}"/>
              </a:ext>
            </a:extLst>
          </p:cNvPr>
          <p:cNvSpPr txBox="1"/>
          <p:nvPr/>
        </p:nvSpPr>
        <p:spPr>
          <a:xfrm rot="18900000">
            <a:off x="3106149" y="1035746"/>
            <a:ext cx="982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C7DB49F4-9681-4CDC-9D86-CFAE2B05F7E8}"/>
              </a:ext>
            </a:extLst>
          </p:cNvPr>
          <p:cNvSpPr txBox="1"/>
          <p:nvPr/>
        </p:nvSpPr>
        <p:spPr>
          <a:xfrm rot="18900000">
            <a:off x="2678289" y="1080936"/>
            <a:ext cx="891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DBAB11FF-1881-410F-86DA-51B680FDD607}"/>
              </a:ext>
            </a:extLst>
          </p:cNvPr>
          <p:cNvSpPr txBox="1"/>
          <p:nvPr/>
        </p:nvSpPr>
        <p:spPr>
          <a:xfrm>
            <a:off x="515999" y="1867780"/>
            <a:ext cx="626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直接连接符 23">
            <a:extLst>
              <a:ext uri="{FF2B5EF4-FFF2-40B4-BE49-F238E27FC236}">
                <a16:creationId xmlns:a16="http://schemas.microsoft.com/office/drawing/2014/main" id="{B75001C5-6427-41B6-9B64-B851339950D3}"/>
              </a:ext>
            </a:extLst>
          </p:cNvPr>
          <p:cNvCxnSpPr>
            <a:cxnSpLocks/>
          </p:cNvCxnSpPr>
          <p:nvPr/>
        </p:nvCxnSpPr>
        <p:spPr>
          <a:xfrm>
            <a:off x="3597321" y="1487354"/>
            <a:ext cx="141867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直接连接符 25">
            <a:extLst>
              <a:ext uri="{FF2B5EF4-FFF2-40B4-BE49-F238E27FC236}">
                <a16:creationId xmlns:a16="http://schemas.microsoft.com/office/drawing/2014/main" id="{23B57D00-253F-404D-92D4-5E8C6917977D}"/>
              </a:ext>
            </a:extLst>
          </p:cNvPr>
          <p:cNvCxnSpPr>
            <a:cxnSpLocks/>
          </p:cNvCxnSpPr>
          <p:nvPr/>
        </p:nvCxnSpPr>
        <p:spPr>
          <a:xfrm>
            <a:off x="1056000" y="1463745"/>
            <a:ext cx="141867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文本框 26">
            <a:extLst>
              <a:ext uri="{FF2B5EF4-FFF2-40B4-BE49-F238E27FC236}">
                <a16:creationId xmlns:a16="http://schemas.microsoft.com/office/drawing/2014/main" id="{327211F0-2F3F-4105-8D5D-1639BA27F9C5}"/>
              </a:ext>
            </a:extLst>
          </p:cNvPr>
          <p:cNvSpPr txBox="1"/>
          <p:nvPr/>
        </p:nvSpPr>
        <p:spPr>
          <a:xfrm>
            <a:off x="3832990" y="1186746"/>
            <a:ext cx="132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 samples 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7A3C01E1-72E6-406F-80D1-9E2994501C82}"/>
              </a:ext>
            </a:extLst>
          </p:cNvPr>
          <p:cNvSpPr txBox="1"/>
          <p:nvPr/>
        </p:nvSpPr>
        <p:spPr>
          <a:xfrm>
            <a:off x="1180864" y="1186746"/>
            <a:ext cx="132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 samples 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D6EE7DE-19FE-4908-AEE8-1436582BAB58}"/>
              </a:ext>
            </a:extLst>
          </p:cNvPr>
          <p:cNvSpPr txBox="1"/>
          <p:nvPr/>
        </p:nvSpPr>
        <p:spPr>
          <a:xfrm>
            <a:off x="1538693" y="4280500"/>
            <a:ext cx="998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ACAM1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6ECB9E13-359C-4F35-B2C5-2C057F877CBD}"/>
              </a:ext>
            </a:extLst>
          </p:cNvPr>
          <p:cNvSpPr txBox="1"/>
          <p:nvPr/>
        </p:nvSpPr>
        <p:spPr>
          <a:xfrm rot="18900000">
            <a:off x="3122507" y="3569069"/>
            <a:ext cx="982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FCA8FD2B-DB3D-4AF1-BB2B-C5B77B97C2C2}"/>
              </a:ext>
            </a:extLst>
          </p:cNvPr>
          <p:cNvSpPr txBox="1"/>
          <p:nvPr/>
        </p:nvSpPr>
        <p:spPr>
          <a:xfrm rot="18900000">
            <a:off x="2678287" y="3618166"/>
            <a:ext cx="891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C130C99F-F745-4913-A4BC-D06B939FECEE}"/>
              </a:ext>
            </a:extLst>
          </p:cNvPr>
          <p:cNvSpPr txBox="1"/>
          <p:nvPr/>
        </p:nvSpPr>
        <p:spPr>
          <a:xfrm>
            <a:off x="540000" y="5432192"/>
            <a:ext cx="90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F5FFA2B-A740-4F85-97E2-6C50764F021F}"/>
              </a:ext>
            </a:extLst>
          </p:cNvPr>
          <p:cNvSpPr txBox="1"/>
          <p:nvPr/>
        </p:nvSpPr>
        <p:spPr>
          <a:xfrm rot="18900000">
            <a:off x="3099203" y="4824467"/>
            <a:ext cx="982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362DBFAB-98AE-4581-8D4F-FB652AA96590}"/>
              </a:ext>
            </a:extLst>
          </p:cNvPr>
          <p:cNvSpPr txBox="1"/>
          <p:nvPr/>
        </p:nvSpPr>
        <p:spPr>
          <a:xfrm rot="18900000">
            <a:off x="2671342" y="4890582"/>
            <a:ext cx="891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e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8" name="图片 37">
            <a:extLst>
              <a:ext uri="{FF2B5EF4-FFF2-40B4-BE49-F238E27FC236}">
                <a16:creationId xmlns:a16="http://schemas.microsoft.com/office/drawing/2014/main" id="{FBA1F506-A3B1-45F7-9103-7A082704D61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975358" y="3104408"/>
            <a:ext cx="1445982" cy="1511559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93606F66-A78E-4733-9178-7A54E2A387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975358" y="5157090"/>
            <a:ext cx="3160642" cy="961619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DDB32157-01BA-4B99-B266-D64D75D9B21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7731602" y="1387647"/>
            <a:ext cx="3160642" cy="1116550"/>
          </a:xfrm>
          <a:prstGeom prst="rect">
            <a:avLst/>
          </a:prstGeom>
        </p:spPr>
      </p:pic>
      <p:sp>
        <p:nvSpPr>
          <p:cNvPr id="47" name="矩形 46">
            <a:extLst>
              <a:ext uri="{FF2B5EF4-FFF2-40B4-BE49-F238E27FC236}">
                <a16:creationId xmlns:a16="http://schemas.microsoft.com/office/drawing/2014/main" id="{C532AB28-299B-4387-A361-9AF8F7C0703B}"/>
              </a:ext>
            </a:extLst>
          </p:cNvPr>
          <p:cNvSpPr/>
          <p:nvPr/>
        </p:nvSpPr>
        <p:spPr>
          <a:xfrm>
            <a:off x="8225617" y="1832241"/>
            <a:ext cx="1046627" cy="369332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48" name="矩形 47">
            <a:extLst>
              <a:ext uri="{FF2B5EF4-FFF2-40B4-BE49-F238E27FC236}">
                <a16:creationId xmlns:a16="http://schemas.microsoft.com/office/drawing/2014/main" id="{2E135A34-AAEA-4D2A-80F4-372D7B5CA202}"/>
              </a:ext>
            </a:extLst>
          </p:cNvPr>
          <p:cNvSpPr/>
          <p:nvPr/>
        </p:nvSpPr>
        <p:spPr>
          <a:xfrm>
            <a:off x="8137994" y="5446405"/>
            <a:ext cx="1371322" cy="34886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49" name="矩形 48">
            <a:extLst>
              <a:ext uri="{FF2B5EF4-FFF2-40B4-BE49-F238E27FC236}">
                <a16:creationId xmlns:a16="http://schemas.microsoft.com/office/drawing/2014/main" id="{281F62B5-E818-4C67-8441-02E03033679D}"/>
              </a:ext>
            </a:extLst>
          </p:cNvPr>
          <p:cNvSpPr/>
          <p:nvPr/>
        </p:nvSpPr>
        <p:spPr>
          <a:xfrm>
            <a:off x="7855141" y="3576795"/>
            <a:ext cx="1371322" cy="348860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noFill/>
            </a:endParaRPr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A8435A12-5D0D-49EA-B16D-852A8BE48BB0}"/>
              </a:ext>
            </a:extLst>
          </p:cNvPr>
          <p:cNvSpPr txBox="1"/>
          <p:nvPr/>
        </p:nvSpPr>
        <p:spPr>
          <a:xfrm rot="18900000">
            <a:off x="8180181" y="1186745"/>
            <a:ext cx="891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FDAFE4B2-A7C3-49D7-8636-A080141ACDE0}"/>
              </a:ext>
            </a:extLst>
          </p:cNvPr>
          <p:cNvSpPr txBox="1"/>
          <p:nvPr/>
        </p:nvSpPr>
        <p:spPr>
          <a:xfrm rot="18900000">
            <a:off x="8665904" y="1170462"/>
            <a:ext cx="982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0B3D1D4D-A265-4AB2-B8CB-A1583278FFBF}"/>
              </a:ext>
            </a:extLst>
          </p:cNvPr>
          <p:cNvSpPr txBox="1"/>
          <p:nvPr/>
        </p:nvSpPr>
        <p:spPr>
          <a:xfrm>
            <a:off x="7542086" y="1893931"/>
            <a:ext cx="6261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AE421F6F-C499-4322-AE2B-0DCD9BC42F66}"/>
              </a:ext>
            </a:extLst>
          </p:cNvPr>
          <p:cNvSpPr txBox="1"/>
          <p:nvPr/>
        </p:nvSpPr>
        <p:spPr>
          <a:xfrm rot="18900000">
            <a:off x="7999199" y="3009333"/>
            <a:ext cx="891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6764E375-7E67-4782-8C63-6C3FF3A893D6}"/>
              </a:ext>
            </a:extLst>
          </p:cNvPr>
          <p:cNvSpPr txBox="1"/>
          <p:nvPr/>
        </p:nvSpPr>
        <p:spPr>
          <a:xfrm rot="18900000">
            <a:off x="8484922" y="2993050"/>
            <a:ext cx="982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39DD39FB-048F-48BE-8A10-7F1A895AB442}"/>
              </a:ext>
            </a:extLst>
          </p:cNvPr>
          <p:cNvSpPr txBox="1"/>
          <p:nvPr/>
        </p:nvSpPr>
        <p:spPr>
          <a:xfrm rot="18900000">
            <a:off x="8399263" y="4911854"/>
            <a:ext cx="891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C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85086FE5-068C-4E89-A25E-B448394D47A0}"/>
              </a:ext>
            </a:extLst>
          </p:cNvPr>
          <p:cNvSpPr txBox="1"/>
          <p:nvPr/>
        </p:nvSpPr>
        <p:spPr>
          <a:xfrm rot="18900000">
            <a:off x="8884986" y="4895571"/>
            <a:ext cx="9823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</a:t>
            </a:r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b="1" i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ASN</a:t>
            </a:r>
            <a:endParaRPr lang="zh-CN" altLang="en-US" sz="1200" b="1" i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7F69460D-6880-4A38-9A23-629905E6DBCC}"/>
              </a:ext>
            </a:extLst>
          </p:cNvPr>
          <p:cNvSpPr txBox="1"/>
          <p:nvPr/>
        </p:nvSpPr>
        <p:spPr>
          <a:xfrm>
            <a:off x="6796929" y="3601626"/>
            <a:ext cx="99810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EACAM1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ED7C80EA-7E5A-4A8D-A050-AE74E627F949}"/>
              </a:ext>
            </a:extLst>
          </p:cNvPr>
          <p:cNvSpPr txBox="1"/>
          <p:nvPr/>
        </p:nvSpPr>
        <p:spPr>
          <a:xfrm>
            <a:off x="7405141" y="5482335"/>
            <a:ext cx="9000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β-Actin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9" name="直接连接符 58">
            <a:extLst>
              <a:ext uri="{FF2B5EF4-FFF2-40B4-BE49-F238E27FC236}">
                <a16:creationId xmlns:a16="http://schemas.microsoft.com/office/drawing/2014/main" id="{BBF454B4-F61D-4FE8-8F5F-61AE1B650BE3}"/>
              </a:ext>
            </a:extLst>
          </p:cNvPr>
          <p:cNvCxnSpPr>
            <a:cxnSpLocks/>
          </p:cNvCxnSpPr>
          <p:nvPr/>
        </p:nvCxnSpPr>
        <p:spPr>
          <a:xfrm>
            <a:off x="9311923" y="1629000"/>
            <a:ext cx="1171409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0" name="文本框 59">
            <a:extLst>
              <a:ext uri="{FF2B5EF4-FFF2-40B4-BE49-F238E27FC236}">
                <a16:creationId xmlns:a16="http://schemas.microsoft.com/office/drawing/2014/main" id="{11EB6DF6-4E1F-4D5B-B0FA-30EE19173659}"/>
              </a:ext>
            </a:extLst>
          </p:cNvPr>
          <p:cNvSpPr txBox="1"/>
          <p:nvPr/>
        </p:nvSpPr>
        <p:spPr>
          <a:xfrm>
            <a:off x="9376158" y="1284643"/>
            <a:ext cx="132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 samples 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8215905B-8E54-4C7D-AACA-345BC9AA7C81}"/>
              </a:ext>
            </a:extLst>
          </p:cNvPr>
          <p:cNvSpPr txBox="1"/>
          <p:nvPr/>
        </p:nvSpPr>
        <p:spPr>
          <a:xfrm>
            <a:off x="9509316" y="4961013"/>
            <a:ext cx="13239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Other samples 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0BA2E15E-620C-4995-A886-42683185D512}"/>
              </a:ext>
            </a:extLst>
          </p:cNvPr>
          <p:cNvCxnSpPr>
            <a:cxnSpLocks/>
          </p:cNvCxnSpPr>
          <p:nvPr/>
        </p:nvCxnSpPr>
        <p:spPr>
          <a:xfrm>
            <a:off x="9585565" y="5339859"/>
            <a:ext cx="969576" cy="0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文本框 42">
            <a:extLst>
              <a:ext uri="{FF2B5EF4-FFF2-40B4-BE49-F238E27FC236}">
                <a16:creationId xmlns:a16="http://schemas.microsoft.com/office/drawing/2014/main" id="{7FBFB62E-2F12-4679-85ED-2A02E0F4FA14}"/>
              </a:ext>
            </a:extLst>
          </p:cNvPr>
          <p:cNvSpPr txBox="1"/>
          <p:nvPr/>
        </p:nvSpPr>
        <p:spPr>
          <a:xfrm>
            <a:off x="5182822" y="1807422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273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33CCD93B-4284-427D-98C8-07DB2B1EA3F1}"/>
              </a:ext>
            </a:extLst>
          </p:cNvPr>
          <p:cNvSpPr txBox="1"/>
          <p:nvPr/>
        </p:nvSpPr>
        <p:spPr>
          <a:xfrm>
            <a:off x="10671659" y="1772133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273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6C3B9D5-3EA7-4769-93E1-B8C1B9CFCEB3}"/>
              </a:ext>
            </a:extLst>
          </p:cNvPr>
          <p:cNvSpPr txBox="1"/>
          <p:nvPr/>
        </p:nvSpPr>
        <p:spPr>
          <a:xfrm>
            <a:off x="10776959" y="5482334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42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98B71AAC-5D6A-4269-ABC2-B89D054C79B9}"/>
              </a:ext>
            </a:extLst>
          </p:cNvPr>
          <p:cNvSpPr txBox="1"/>
          <p:nvPr/>
        </p:nvSpPr>
        <p:spPr>
          <a:xfrm>
            <a:off x="5306179" y="5386025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42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文本框 64">
            <a:extLst>
              <a:ext uri="{FF2B5EF4-FFF2-40B4-BE49-F238E27FC236}">
                <a16:creationId xmlns:a16="http://schemas.microsoft.com/office/drawing/2014/main" id="{1EB1CA2D-AE18-47F4-BCDC-2286B0A4EEB2}"/>
              </a:ext>
            </a:extLst>
          </p:cNvPr>
          <p:cNvSpPr txBox="1"/>
          <p:nvPr/>
        </p:nvSpPr>
        <p:spPr>
          <a:xfrm>
            <a:off x="3664021" y="4277218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10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文本框 65">
            <a:extLst>
              <a:ext uri="{FF2B5EF4-FFF2-40B4-BE49-F238E27FC236}">
                <a16:creationId xmlns:a16="http://schemas.microsoft.com/office/drawing/2014/main" id="{282079C5-A7CF-4ED3-809A-19D385FAF0EA}"/>
              </a:ext>
            </a:extLst>
          </p:cNvPr>
          <p:cNvSpPr txBox="1"/>
          <p:nvPr/>
        </p:nvSpPr>
        <p:spPr>
          <a:xfrm>
            <a:off x="9421340" y="3601625"/>
            <a:ext cx="8202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110kDa</a:t>
            </a:r>
            <a:endParaRPr lang="zh-CN" altLang="en-US" sz="1200" b="1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630475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34</Words>
  <Application>Microsoft Office PowerPoint</Application>
  <PresentationFormat>宽屏</PresentationFormat>
  <Paragraphs>7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昕航 孟</dc:creator>
  <cp:lastModifiedBy>昕航 孟</cp:lastModifiedBy>
  <cp:revision>4</cp:revision>
  <dcterms:created xsi:type="dcterms:W3CDTF">2024-10-09T03:32:49Z</dcterms:created>
  <dcterms:modified xsi:type="dcterms:W3CDTF">2024-10-31T06:45:33Z</dcterms:modified>
</cp:coreProperties>
</file>